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14" d="100"/>
          <a:sy n="214" d="100"/>
        </p:scale>
        <p:origin x="-354" y="10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7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0380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7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9749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7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4566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7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8231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7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7778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7.05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2380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7.05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0693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7.05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5117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7.05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5618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7.05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2266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7.05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646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8FC42-D9AB-456B-B831-CBBD0C25019A}" type="datetimeFigureOut">
              <a:rPr lang="de-DE" smtClean="0"/>
              <a:t>17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120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19" b="14330"/>
          <a:stretch/>
        </p:blipFill>
        <p:spPr>
          <a:xfrm>
            <a:off x="1141589" y="2453689"/>
            <a:ext cx="2334768" cy="1810679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793" b="15958"/>
          <a:stretch/>
        </p:blipFill>
        <p:spPr>
          <a:xfrm>
            <a:off x="3516248" y="2453689"/>
            <a:ext cx="2240280" cy="1810679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2780928" y="9120172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e-2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185081" y="245369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5465069" y="245369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Gerade Verbindung mit Pfeil 27"/>
          <p:cNvCxnSpPr/>
          <p:nvPr/>
        </p:nvCxnSpPr>
        <p:spPr>
          <a:xfrm rot="10800000">
            <a:off x="3593748" y="3322520"/>
            <a:ext cx="144000" cy="0"/>
          </a:xfrm>
          <a:prstGeom prst="straightConnector1">
            <a:avLst/>
          </a:prstGeom>
          <a:ln w="12700">
            <a:solidFill>
              <a:schemeClr val="tx1"/>
            </a:solidFill>
            <a:headEnd type="stealth" w="sm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mit Pfeil 29"/>
          <p:cNvCxnSpPr/>
          <p:nvPr/>
        </p:nvCxnSpPr>
        <p:spPr>
          <a:xfrm rot="10800000">
            <a:off x="1200524" y="3321291"/>
            <a:ext cx="144000" cy="0"/>
          </a:xfrm>
          <a:prstGeom prst="straightConnector1">
            <a:avLst/>
          </a:prstGeom>
          <a:ln w="12700">
            <a:solidFill>
              <a:schemeClr val="tx1"/>
            </a:solidFill>
            <a:headEnd type="stealth" w="sm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feld 46"/>
          <p:cNvSpPr txBox="1"/>
          <p:nvPr/>
        </p:nvSpPr>
        <p:spPr>
          <a:xfrm>
            <a:off x="952002" y="323819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de-DE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952002" y="30106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de-DE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952002" y="285373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de-DE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908720" y="268173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de-DE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952002" y="347229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de-DE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952002" y="36347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de-DE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952002" y="38090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de-DE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952002" y="40743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de-DE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908720" y="246798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35</a:t>
            </a:r>
            <a:endParaRPr lang="de-DE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1105312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1324664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1529730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1782416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2004149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2233025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2490473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2724111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2979178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3501008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3731407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3945139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4163633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4405937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4638717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4878640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5116182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5351343" y="2288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3186626" y="228870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5531574" y="228870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2609146" y="4084801"/>
            <a:ext cx="9589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B: anti-FLOT1</a:t>
            </a:r>
            <a:endParaRPr lang="de-DE" sz="800" b="1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4886030" y="4084801"/>
            <a:ext cx="9589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800" b="1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B: anti-FLOT2</a:t>
            </a:r>
            <a:endParaRPr lang="de-DE" sz="800" b="1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 rot="18273128">
            <a:off x="1549908" y="2105599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 rot="18273128">
            <a:off x="1352868" y="2120782"/>
            <a:ext cx="41710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 rot="18273128">
            <a:off x="1806429" y="2105599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2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 rot="18273128">
            <a:off x="2026470" y="2102298"/>
            <a:ext cx="46198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 rot="18273128">
            <a:off x="2251547" y="2102298"/>
            <a:ext cx="46198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2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 rot="18273128">
            <a:off x="2493842" y="2079194"/>
            <a:ext cx="51809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1/2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 rot="18273128">
            <a:off x="2668391" y="1955750"/>
            <a:ext cx="8178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+ flot-2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 rot="18273128">
            <a:off x="2983077" y="2075893"/>
            <a:ext cx="5261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1/2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 rot="18273128">
            <a:off x="3156813" y="1955750"/>
            <a:ext cx="8178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+ flot-2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 rot="18273128">
            <a:off x="3962882" y="2105599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 rot="18273128">
            <a:off x="3756788" y="2120782"/>
            <a:ext cx="41710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 rot="18273128">
            <a:off x="4192241" y="2105599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2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 rot="18273128">
            <a:off x="4430390" y="2102298"/>
            <a:ext cx="46198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 rot="18273128">
            <a:off x="4655467" y="2102298"/>
            <a:ext cx="46198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2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 rot="18273128">
            <a:off x="4884181" y="2079194"/>
            <a:ext cx="51809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1/2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 rot="18273128">
            <a:off x="5058730" y="1955750"/>
            <a:ext cx="8178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+ flot-2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 rot="18273128">
            <a:off x="5355308" y="2075893"/>
            <a:ext cx="5261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1/2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 rot="18273128">
            <a:off x="5501882" y="1955750"/>
            <a:ext cx="81785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lot-1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+ flot-2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027376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A4-Papier (210x297 mm)</PresentationFormat>
  <Paragraphs>5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EUROIMMUN A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ahn, Stefanie</dc:creator>
  <cp:lastModifiedBy>Hahn, Stefanie</cp:lastModifiedBy>
  <cp:revision>60</cp:revision>
  <cp:lastPrinted>2017-05-17T10:38:30Z</cp:lastPrinted>
  <dcterms:created xsi:type="dcterms:W3CDTF">2015-08-27T11:58:00Z</dcterms:created>
  <dcterms:modified xsi:type="dcterms:W3CDTF">2017-05-17T10:39:38Z</dcterms:modified>
</cp:coreProperties>
</file>